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5843" autoAdjust="0"/>
  </p:normalViewPr>
  <p:slideViewPr>
    <p:cSldViewPr snapToGrid="0">
      <p:cViewPr varScale="1">
        <p:scale>
          <a:sx n="47" d="100"/>
          <a:sy n="47" d="100"/>
        </p:scale>
        <p:origin x="16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ppadol Kietsiriroje" userId="569ac48280451d10" providerId="LiveId" clId="{6A6AEB36-14D3-43F2-83BA-B059542624E6}"/>
    <pc:docChg chg="modSld">
      <pc:chgData name="Noppadol Kietsiriroje" userId="569ac48280451d10" providerId="LiveId" clId="{6A6AEB36-14D3-43F2-83BA-B059542624E6}" dt="2021-01-26T15:28:43.343" v="12" actId="113"/>
      <pc:docMkLst>
        <pc:docMk/>
      </pc:docMkLst>
      <pc:sldChg chg="modSp mod modNotesTx">
        <pc:chgData name="Noppadol Kietsiriroje" userId="569ac48280451d10" providerId="LiveId" clId="{6A6AEB36-14D3-43F2-83BA-B059542624E6}" dt="2021-01-26T15:28:43.343" v="12" actId="113"/>
        <pc:sldMkLst>
          <pc:docMk/>
          <pc:sldMk cId="2734740258" sldId="259"/>
        </pc:sldMkLst>
        <pc:graphicFrameChg chg="modGraphic">
          <ac:chgData name="Noppadol Kietsiriroje" userId="569ac48280451d10" providerId="LiveId" clId="{6A6AEB36-14D3-43F2-83BA-B059542624E6}" dt="2021-01-25T12:11:27.611" v="11" actId="6549"/>
          <ac:graphicFrameMkLst>
            <pc:docMk/>
            <pc:sldMk cId="2734740258" sldId="259"/>
            <ac:graphicFrameMk id="17" creationId="{65481EA1-0813-450F-A062-5CD0FEE99898}"/>
          </ac:graphicFrameMkLst>
        </pc:graphicFrameChg>
      </pc:sldChg>
    </pc:docChg>
  </pc:docChgLst>
  <pc:docChgLst>
    <pc:chgData name="Noppadol Kietsiriroje" userId="569ac48280451d10" providerId="LiveId" clId="{CFCF65D7-AD82-46C3-9ED9-03A426314A98}"/>
    <pc:docChg chg="delSld">
      <pc:chgData name="Noppadol Kietsiriroje" userId="569ac48280451d10" providerId="LiveId" clId="{CFCF65D7-AD82-46C3-9ED9-03A426314A98}" dt="2021-01-19T10:39:21.766" v="0" actId="47"/>
      <pc:docMkLst>
        <pc:docMk/>
      </pc:docMkLst>
      <pc:sldChg chg="del">
        <pc:chgData name="Noppadol Kietsiriroje" userId="569ac48280451d10" providerId="LiveId" clId="{CFCF65D7-AD82-46C3-9ED9-03A426314A98}" dt="2021-01-19T10:39:21.766" v="0" actId="47"/>
        <pc:sldMkLst>
          <pc:docMk/>
          <pc:sldMk cId="940794102" sldId="256"/>
        </pc:sldMkLst>
      </pc:sldChg>
      <pc:sldChg chg="del">
        <pc:chgData name="Noppadol Kietsiriroje" userId="569ac48280451d10" providerId="LiveId" clId="{CFCF65D7-AD82-46C3-9ED9-03A426314A98}" dt="2021-01-19T10:39:21.766" v="0" actId="47"/>
        <pc:sldMkLst>
          <pc:docMk/>
          <pc:sldMk cId="4073832493" sldId="257"/>
        </pc:sldMkLst>
      </pc:sldChg>
      <pc:sldChg chg="del">
        <pc:chgData name="Noppadol Kietsiriroje" userId="569ac48280451d10" providerId="LiveId" clId="{CFCF65D7-AD82-46C3-9ED9-03A426314A98}" dt="2021-01-19T10:39:21.766" v="0" actId="47"/>
        <pc:sldMkLst>
          <pc:docMk/>
          <pc:sldMk cId="2766780528" sldId="258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69ac48280451d10/PhD%20UoLeeds/PhD%20UoLeeds/Literature%20reviews/Anticoag%20in%20DM_Lancet/manuscript/EHJ%20version/figure/whisker%20plot%20CAD%20PAD%20D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69ac48280451d10/PhD%20UoLeeds/PhD%20UoLeeds/Literature%20reviews/Anticoag%20in%20DM_Lancet/manuscript/EHJ%20version/figure/whisker%20plot%20CAD%20PAD%20DM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69ac48280451d10/PhD%20UoLeeds/PhD%20UoLeeds/Literature%20reviews/Anticoag%20in%20DM_Lancet/manuscript/EHJ%20version/figure/whisker%20plot%20CAD%20PAD%20DM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69ac48280451d10/PhD%20UoLeeds/PhD%20UoLeeds/Literature%20reviews/Anticoag%20in%20DM_Lancet/manuscript/EHJ%20version/figure/whisker%20plot%20CAD%20PAD%20DM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296396194996996E-2"/>
          <c:y val="0.10754530111471566"/>
          <c:w val="0.82446509120766864"/>
          <c:h val="0.775130078665233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537-4A81-90F7-399905801525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537-4A81-90F7-399905801525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537-4A81-90F7-399905801525}"/>
              </c:ext>
            </c:extLst>
          </c:dPt>
          <c:errBars>
            <c:errBarType val="both"/>
            <c:errValType val="cust"/>
            <c:noEndCap val="0"/>
            <c:plus>
              <c:numRef>
                <c:f>'[whisker plot CAD PAD DM.xlsx]Bleeding'!$N$21:$N$30</c:f>
                <c:numCache>
                  <c:formatCode>General</c:formatCode>
                  <c:ptCount val="10"/>
                  <c:pt idx="0">
                    <c:v>71</c:v>
                  </c:pt>
                  <c:pt idx="1">
                    <c:v>101.99999999999997</c:v>
                  </c:pt>
                  <c:pt idx="2">
                    <c:v>108</c:v>
                  </c:pt>
                  <c:pt idx="3">
                    <c:v>187.99999999999991</c:v>
                  </c:pt>
                  <c:pt idx="4">
                    <c:v>45.999999999999986</c:v>
                  </c:pt>
                  <c:pt idx="5">
                    <c:v>61</c:v>
                  </c:pt>
                  <c:pt idx="6">
                    <c:v>0</c:v>
                  </c:pt>
                  <c:pt idx="7">
                    <c:v>0</c:v>
                  </c:pt>
                  <c:pt idx="8">
                    <c:v>64.999999999999986</c:v>
                  </c:pt>
                  <c:pt idx="9">
                    <c:v>224.00000000000003</c:v>
                  </c:pt>
                </c:numCache>
              </c:numRef>
            </c:plus>
            <c:minus>
              <c:numRef>
                <c:f>'[whisker plot CAD PAD DM.xlsx]Bleeding'!$M$21:$M$30</c:f>
                <c:numCache>
                  <c:formatCode>General</c:formatCode>
                  <c:ptCount val="10"/>
                  <c:pt idx="0">
                    <c:v>49</c:v>
                  </c:pt>
                  <c:pt idx="1">
                    <c:v>62</c:v>
                  </c:pt>
                  <c:pt idx="2">
                    <c:v>73</c:v>
                  </c:pt>
                  <c:pt idx="3">
                    <c:v>107.00000000000003</c:v>
                  </c:pt>
                  <c:pt idx="4">
                    <c:v>35.999999999999993</c:v>
                  </c:pt>
                  <c:pt idx="5">
                    <c:v>45</c:v>
                  </c:pt>
                  <c:pt idx="6">
                    <c:v>0</c:v>
                  </c:pt>
                  <c:pt idx="7">
                    <c:v>0</c:v>
                  </c:pt>
                  <c:pt idx="8">
                    <c:v>40</c:v>
                  </c:pt>
                  <c:pt idx="9">
                    <c:v>117.0000000000000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whisker plot CAD PAD DM.xlsx]Bleeding'!$M$4:$M$13</c:f>
              <c:numCache>
                <c:formatCode>0.00</c:formatCode>
                <c:ptCount val="10"/>
                <c:pt idx="0">
                  <c:v>63.999999999999993</c:v>
                </c:pt>
                <c:pt idx="1">
                  <c:v>55.000000000000007</c:v>
                </c:pt>
                <c:pt idx="2">
                  <c:v>125</c:v>
                </c:pt>
                <c:pt idx="3">
                  <c:v>147.00000000000003</c:v>
                </c:pt>
                <c:pt idx="4">
                  <c:v>69</c:v>
                </c:pt>
                <c:pt idx="5">
                  <c:v>70</c:v>
                </c:pt>
                <c:pt idx="8">
                  <c:v>1.0000000000000009</c:v>
                </c:pt>
                <c:pt idx="9">
                  <c:v>145.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537-4A81-90F7-3999058015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75524984"/>
        <c:axId val="475521784"/>
      </c:barChart>
      <c:catAx>
        <c:axId val="475524984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475521784"/>
        <c:crosses val="autoZero"/>
        <c:auto val="1"/>
        <c:lblAlgn val="ctr"/>
        <c:lblOffset val="100"/>
        <c:noMultiLvlLbl val="0"/>
      </c:catAx>
      <c:valAx>
        <c:axId val="475521784"/>
        <c:scaling>
          <c:orientation val="minMax"/>
          <c:max val="200"/>
          <c:min val="-200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/>
                  <a:t>Major</a:t>
                </a:r>
                <a:r>
                  <a:rPr lang="en-GB" sz="1600" baseline="0"/>
                  <a:t> bleeding</a:t>
                </a:r>
                <a:endParaRPr lang="en-GB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5524984"/>
        <c:crosses val="autoZero"/>
        <c:crossBetween val="between"/>
        <c:majorUnit val="100"/>
        <c:min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8611111111111"/>
          <c:y val="0.12755048705582608"/>
          <c:w val="0.75260000000000005"/>
          <c:h val="0.76301868277915219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742-4006-A5B2-71E8F83AA562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742-4006-A5B2-71E8F83AA562}"/>
              </c:ext>
            </c:extLst>
          </c:dPt>
          <c:dPt>
            <c:idx val="8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742-4006-A5B2-71E8F83AA562}"/>
              </c:ext>
            </c:extLst>
          </c:dPt>
          <c:dPt>
            <c:idx val="10"/>
            <c:invertIfNegative val="0"/>
            <c:bubble3D val="0"/>
            <c:spPr>
              <a:pattFill prst="lt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742-4006-A5B2-71E8F83AA562}"/>
              </c:ext>
            </c:extLst>
          </c:dPt>
          <c:errBars>
            <c:errBarType val="both"/>
            <c:errValType val="cust"/>
            <c:noEndCap val="0"/>
            <c:plus>
              <c:numRef>
                <c:f>'[whisker plot CAD PAD DM.xlsx]Bleeding (3)'!$N$28:$N$39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11.000000000000011</c:v>
                  </c:pt>
                  <c:pt idx="5">
                    <c:v>29.000000000000004</c:v>
                  </c:pt>
                  <c:pt idx="6">
                    <c:v>14</c:v>
                  </c:pt>
                  <c:pt idx="7">
                    <c:v>31.999999999999982</c:v>
                  </c:pt>
                  <c:pt idx="8">
                    <c:v>13.000000000000002</c:v>
                  </c:pt>
                  <c:pt idx="9">
                    <c:v>27.999999999999989</c:v>
                  </c:pt>
                  <c:pt idx="10">
                    <c:v>15.999999999999993</c:v>
                  </c:pt>
                  <c:pt idx="11">
                    <c:v>24</c:v>
                  </c:pt>
                </c:numCache>
              </c:numRef>
            </c:plus>
            <c:minus>
              <c:numRef>
                <c:f>'[whisker plot CAD PAD DM.xlsx]Bleeding (3)'!$M$28:$M$39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8.9999999999999929</c:v>
                  </c:pt>
                  <c:pt idx="5">
                    <c:v>21.999999999999996</c:v>
                  </c:pt>
                  <c:pt idx="6">
                    <c:v>11.999999999999998</c:v>
                  </c:pt>
                  <c:pt idx="7">
                    <c:v>25.000000000000011</c:v>
                  </c:pt>
                  <c:pt idx="8">
                    <c:v>11.000000000000011</c:v>
                  </c:pt>
                  <c:pt idx="9">
                    <c:v>21.000000000000007</c:v>
                  </c:pt>
                  <c:pt idx="10">
                    <c:v>14.000000000000002</c:v>
                  </c:pt>
                  <c:pt idx="11">
                    <c:v>18.9999999999999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whisker plot CAD PAD DM.xlsx]Bleeding (3)'!$M$4:$M$15</c:f>
              <c:numCache>
                <c:formatCode>#,##0.00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-31.000000000000007</c:v>
                </c:pt>
                <c:pt idx="5">
                  <c:v>-4.0000000000000036</c:v>
                </c:pt>
                <c:pt idx="6">
                  <c:v>-6.9999999999999947</c:v>
                </c:pt>
                <c:pt idx="7">
                  <c:v>12.000000000000011</c:v>
                </c:pt>
                <c:pt idx="8">
                  <c:v>-19.999999999999996</c:v>
                </c:pt>
                <c:pt idx="9">
                  <c:v>-8.9999999999999964</c:v>
                </c:pt>
                <c:pt idx="10">
                  <c:v>4.0000000000000036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742-4006-A5B2-71E8F83AA5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75524984"/>
        <c:axId val="475521784"/>
      </c:barChart>
      <c:catAx>
        <c:axId val="475524984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475521784"/>
        <c:crosses val="autoZero"/>
        <c:auto val="1"/>
        <c:lblAlgn val="ctr"/>
        <c:lblOffset val="100"/>
        <c:noMultiLvlLbl val="0"/>
      </c:catAx>
      <c:valAx>
        <c:axId val="475521784"/>
        <c:scaling>
          <c:orientation val="minMax"/>
          <c:max val="50"/>
          <c:min val="-50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/>
                  <a:t>Major</a:t>
                </a:r>
                <a:r>
                  <a:rPr lang="en-GB" sz="1600" baseline="0"/>
                  <a:t> bleeding</a:t>
                </a:r>
                <a:endParaRPr lang="en-GB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5524984"/>
        <c:crosses val="autoZero"/>
        <c:crossBetween val="between"/>
        <c:majorUnit val="25"/>
        <c:min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5EE-404B-8A32-D7B691622061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5EE-404B-8A32-D7B691622061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5EE-404B-8A32-D7B691622061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5EE-404B-8A32-D7B691622061}"/>
              </c:ext>
            </c:extLst>
          </c:dPt>
          <c:dPt>
            <c:idx val="8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5EE-404B-8A32-D7B691622061}"/>
              </c:ext>
            </c:extLst>
          </c:dPt>
          <c:errBars>
            <c:errBarType val="both"/>
            <c:errValType val="cust"/>
            <c:noEndCap val="0"/>
            <c:plus>
              <c:numRef>
                <c:f>'[whisker plot CAD PAD DM.xlsx]MACE'!$N$28:$N$37</c:f>
                <c:numCache>
                  <c:formatCode>General</c:formatCode>
                  <c:ptCount val="10"/>
                  <c:pt idx="0">
                    <c:v>-15</c:v>
                  </c:pt>
                  <c:pt idx="1">
                    <c:v>-30.000000000000004</c:v>
                  </c:pt>
                  <c:pt idx="2">
                    <c:v>-14.000000000000002</c:v>
                  </c:pt>
                  <c:pt idx="3">
                    <c:v>-16.000000000000004</c:v>
                  </c:pt>
                  <c:pt idx="4">
                    <c:v>-16.000000000000007</c:v>
                  </c:pt>
                  <c:pt idx="5">
                    <c:v>-16</c:v>
                  </c:pt>
                  <c:pt idx="6">
                    <c:v>-25</c:v>
                  </c:pt>
                  <c:pt idx="7">
                    <c:v>-22.000000000000011</c:v>
                  </c:pt>
                  <c:pt idx="8">
                    <c:v>-14.000000000000002</c:v>
                  </c:pt>
                  <c:pt idx="9">
                    <c:v>-17.000000000000014</c:v>
                  </c:pt>
                </c:numCache>
              </c:numRef>
            </c:plus>
            <c:minus>
              <c:numRef>
                <c:f>'[whisker plot CAD PAD DM.xlsx]MACE'!$M$28:$M$37</c:f>
                <c:numCache>
                  <c:formatCode>General</c:formatCode>
                  <c:ptCount val="10"/>
                  <c:pt idx="0">
                    <c:v>-13</c:v>
                  </c:pt>
                  <c:pt idx="1">
                    <c:v>-23</c:v>
                  </c:pt>
                  <c:pt idx="2">
                    <c:v>-12</c:v>
                  </c:pt>
                  <c:pt idx="3">
                    <c:v>-15.000000000000004</c:v>
                  </c:pt>
                  <c:pt idx="4">
                    <c:v>-13</c:v>
                  </c:pt>
                  <c:pt idx="5">
                    <c:v>-13</c:v>
                  </c:pt>
                  <c:pt idx="6">
                    <c:v>-18.999999999999993</c:v>
                  </c:pt>
                  <c:pt idx="7">
                    <c:v>-15.999999999999993</c:v>
                  </c:pt>
                  <c:pt idx="8">
                    <c:v>-11.999999999999996</c:v>
                  </c:pt>
                  <c:pt idx="9">
                    <c:v>-14.99999999999999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whisker plot CAD PAD DM.xlsx]MACE'!$M$4:$M$13</c:f>
              <c:numCache>
                <c:formatCode>#,##0.00</c:formatCode>
                <c:ptCount val="10"/>
                <c:pt idx="0">
                  <c:v>41</c:v>
                </c:pt>
                <c:pt idx="1">
                  <c:v>5.0000000000000044</c:v>
                </c:pt>
                <c:pt idx="2">
                  <c:v>16.000000000000004</c:v>
                </c:pt>
                <c:pt idx="3">
                  <c:v>16.000000000000004</c:v>
                </c:pt>
                <c:pt idx="4">
                  <c:v>23</c:v>
                </c:pt>
                <c:pt idx="5">
                  <c:v>26</c:v>
                </c:pt>
                <c:pt idx="6">
                  <c:v>31.000000000000007</c:v>
                </c:pt>
                <c:pt idx="7">
                  <c:v>31.000000000000007</c:v>
                </c:pt>
                <c:pt idx="8">
                  <c:v>20.999999999999996</c:v>
                </c:pt>
                <c:pt idx="9">
                  <c:v>6.00000000000000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5EE-404B-8A32-D7B6916220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15771792"/>
        <c:axId val="715776912"/>
      </c:barChart>
      <c:catAx>
        <c:axId val="715771792"/>
        <c:scaling>
          <c:orientation val="maxMin"/>
        </c:scaling>
        <c:delete val="1"/>
        <c:axPos val="r"/>
        <c:numFmt formatCode="General" sourceLinked="1"/>
        <c:majorTickMark val="out"/>
        <c:minorTickMark val="none"/>
        <c:tickLblPos val="nextTo"/>
        <c:crossAx val="715776912"/>
        <c:crossesAt val="0"/>
        <c:auto val="1"/>
        <c:lblAlgn val="ctr"/>
        <c:lblOffset val="100"/>
        <c:noMultiLvlLbl val="0"/>
      </c:catAx>
      <c:valAx>
        <c:axId val="715776912"/>
        <c:scaling>
          <c:orientation val="maxMin"/>
          <c:max val="100"/>
          <c:min val="0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/>
                  <a:t>MA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5771792"/>
        <c:crosses val="autoZero"/>
        <c:crossBetween val="between"/>
        <c:majorUnit val="20"/>
        <c:min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0C-433C-924F-83AE94AD7E12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F0C-433C-924F-83AE94AD7E12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F0C-433C-924F-83AE94AD7E12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F0C-433C-924F-83AE94AD7E12}"/>
              </c:ext>
            </c:extLst>
          </c:dPt>
          <c:dPt>
            <c:idx val="8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F0C-433C-924F-83AE94AD7E12}"/>
              </c:ext>
            </c:extLst>
          </c:dPt>
          <c:dPt>
            <c:idx val="10"/>
            <c:invertIfNegative val="0"/>
            <c:bubble3D val="0"/>
            <c:spPr>
              <a:pattFill prst="lt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F0C-433C-924F-83AE94AD7E12}"/>
              </c:ext>
            </c:extLst>
          </c:dPt>
          <c:errBars>
            <c:errBarType val="both"/>
            <c:errValType val="cust"/>
            <c:noEndCap val="0"/>
            <c:plus>
              <c:numRef>
                <c:f>'[whisker plot CAD PAD DM.xlsx]MACE (2)'!$N$30:$N$41</c:f>
                <c:numCache>
                  <c:formatCode>General</c:formatCode>
                  <c:ptCount val="12"/>
                  <c:pt idx="0">
                    <c:v>-14.999999999999989</c:v>
                  </c:pt>
                  <c:pt idx="1">
                    <c:v>-32.000000000000007</c:v>
                  </c:pt>
                  <c:pt idx="2">
                    <c:v>-15.999999999999991</c:v>
                  </c:pt>
                  <c:pt idx="3">
                    <c:v>-26.999999999999993</c:v>
                  </c:pt>
                  <c:pt idx="4">
                    <c:v>-15.999999999999993</c:v>
                  </c:pt>
                  <c:pt idx="5">
                    <c:v>-30.000000000000004</c:v>
                  </c:pt>
                  <c:pt idx="6">
                    <c:v>-15.999999999999996</c:v>
                  </c:pt>
                  <c:pt idx="7">
                    <c:v>-30.000000000000004</c:v>
                  </c:pt>
                  <c:pt idx="8">
                    <c:v>-20.000000000000007</c:v>
                  </c:pt>
                  <c:pt idx="9">
                    <c:v>-33.000000000000007</c:v>
                  </c:pt>
                  <c:pt idx="10">
                    <c:v>-16.999999999999993</c:v>
                  </c:pt>
                  <c:pt idx="11">
                    <c:v>-26.000000000000011</c:v>
                  </c:pt>
                </c:numCache>
              </c:numRef>
            </c:plus>
            <c:minus>
              <c:numRef>
                <c:f>'[whisker plot CAD PAD DM.xlsx]MACE (2)'!$M$30:$M$41</c:f>
                <c:numCache>
                  <c:formatCode>General</c:formatCode>
                  <c:ptCount val="12"/>
                  <c:pt idx="0">
                    <c:v>-13.000000000000007</c:v>
                  </c:pt>
                  <c:pt idx="1">
                    <c:v>-23</c:v>
                  </c:pt>
                  <c:pt idx="2">
                    <c:v>-14.000000000000004</c:v>
                  </c:pt>
                  <c:pt idx="3">
                    <c:v>-21.000000000000007</c:v>
                  </c:pt>
                  <c:pt idx="4">
                    <c:v>-13.000000000000004</c:v>
                  </c:pt>
                  <c:pt idx="5">
                    <c:v>-22</c:v>
                  </c:pt>
                  <c:pt idx="6">
                    <c:v>-13</c:v>
                  </c:pt>
                  <c:pt idx="7">
                    <c:v>-20.000000000000007</c:v>
                  </c:pt>
                  <c:pt idx="8">
                    <c:v>-17.000000000000004</c:v>
                  </c:pt>
                  <c:pt idx="9">
                    <c:v>-23</c:v>
                  </c:pt>
                  <c:pt idx="10">
                    <c:v>-13.000000000000004</c:v>
                  </c:pt>
                  <c:pt idx="11">
                    <c:v>-18.99999999999999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whisker plot CAD PAD DM.xlsx]MACE (2)'!$M$4:$M$15</c:f>
              <c:numCache>
                <c:formatCode>0.00</c:formatCode>
                <c:ptCount val="12"/>
                <c:pt idx="0">
                  <c:v>32.999999999999993</c:v>
                </c:pt>
                <c:pt idx="1">
                  <c:v>25</c:v>
                </c:pt>
                <c:pt idx="2">
                  <c:v>21.999999999999996</c:v>
                </c:pt>
                <c:pt idx="3">
                  <c:v>6.9999999999999947</c:v>
                </c:pt>
                <c:pt idx="4">
                  <c:v>20.999999999999996</c:v>
                </c:pt>
                <c:pt idx="5">
                  <c:v>25</c:v>
                </c:pt>
                <c:pt idx="6">
                  <c:v>34</c:v>
                </c:pt>
                <c:pt idx="7">
                  <c:v>39</c:v>
                </c:pt>
                <c:pt idx="8">
                  <c:v>8.9999999999999964</c:v>
                </c:pt>
                <c:pt idx="9">
                  <c:v>26</c:v>
                </c:pt>
                <c:pt idx="10">
                  <c:v>20.999999999999996</c:v>
                </c:pt>
                <c:pt idx="11">
                  <c:v>18.0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F0C-433C-924F-83AE94AD7E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15771792"/>
        <c:axId val="715776912"/>
      </c:barChart>
      <c:catAx>
        <c:axId val="715771792"/>
        <c:scaling>
          <c:orientation val="maxMin"/>
        </c:scaling>
        <c:delete val="1"/>
        <c:axPos val="r"/>
        <c:numFmt formatCode="General" sourceLinked="1"/>
        <c:majorTickMark val="out"/>
        <c:minorTickMark val="none"/>
        <c:tickLblPos val="nextTo"/>
        <c:crossAx val="715776912"/>
        <c:crossesAt val="0"/>
        <c:auto val="1"/>
        <c:lblAlgn val="ctr"/>
        <c:lblOffset val="100"/>
        <c:noMultiLvlLbl val="0"/>
      </c:catAx>
      <c:valAx>
        <c:axId val="715776912"/>
        <c:scaling>
          <c:orientation val="maxMin"/>
          <c:max val="100"/>
          <c:min val="0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/>
                  <a:t>Primary outcom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5771792"/>
        <c:crosses val="autoZero"/>
        <c:crossBetween val="between"/>
        <c:majorUnit val="20"/>
        <c:min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1702</cdr:x>
      <cdr:y>0.13516</cdr:y>
    </cdr:from>
    <cdr:to>
      <cdr:x>0.51702</cdr:x>
      <cdr:y>0.89521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F3FF07A1-B8E3-4D98-979A-D0FFEC549F66}"/>
            </a:ext>
          </a:extLst>
        </cdr:cNvPr>
        <cdr:cNvCxnSpPr/>
      </cdr:nvCxnSpPr>
      <cdr:spPr>
        <a:xfrm xmlns:a="http://schemas.openxmlformats.org/drawingml/2006/main">
          <a:off x="1209818" y="451229"/>
          <a:ext cx="0" cy="2537448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46BF8A-8023-4C50-98A2-D6601D8D92D5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AE6C8B-0D33-4E64-97FF-DA45336112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0091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 err="1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</a:t>
            </a:r>
            <a:r>
              <a:rPr lang="en-GB" sz="1200" b="1" dirty="0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Figure 1. The effects of more aggressive antithrombotic strategy on vascular events and bleeding risk in different clinical trials, presented separately for the diabetes and non-diabetes cohorts. </a:t>
            </a:r>
            <a:r>
              <a:rPr lang="en-US" sz="1200" b="0" dirty="0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A) coronary artery and/or peripheral artery disease (PAD), (B) acute minor stroke/transient </a:t>
            </a:r>
            <a:r>
              <a:rPr lang="en-US" sz="1200" b="0" dirty="0" err="1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ischaemic</a:t>
            </a:r>
            <a:r>
              <a:rPr lang="en-US" sz="1200" b="0" dirty="0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attack (TIA) or embolic stroke. DAPT: dual antiplatelet therapy.</a:t>
            </a:r>
            <a:endParaRPr lang="en-GB" sz="1200" b="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AE6C8B-0D33-4E64-97FF-DA453361123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1967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0420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213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3956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123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1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8095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452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955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6856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715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9502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4A817-834F-4BF3-8858-74664F9C1F7A}" type="datetimeFigureOut">
              <a:rPr lang="en-GB" smtClean="0"/>
              <a:t>2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F5BF48-C2C3-4576-BEC3-64701A7060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8989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3110814-E259-48BC-B10D-18579EFF8536}"/>
              </a:ext>
            </a:extLst>
          </p:cNvPr>
          <p:cNvSpPr txBox="1"/>
          <p:nvPr/>
        </p:nvSpPr>
        <p:spPr>
          <a:xfrm>
            <a:off x="5451180" y="6192392"/>
            <a:ext cx="1660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% reduction (95%CI)</a:t>
            </a:r>
            <a:endParaRPr lang="en-GB" sz="14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FE8E24B-BF01-4193-BF59-DB4CCC1688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2993370"/>
              </p:ext>
            </p:extLst>
          </p:nvPr>
        </p:nvGraphicFramePr>
        <p:xfrm>
          <a:off x="232614" y="3171175"/>
          <a:ext cx="4775423" cy="279527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49053">
                  <a:extLst>
                    <a:ext uri="{9D8B030D-6E8A-4147-A177-3AD203B41FA5}">
                      <a16:colId xmlns:a16="http://schemas.microsoft.com/office/drawing/2014/main" val="2062930114"/>
                    </a:ext>
                  </a:extLst>
                </a:gridCol>
                <a:gridCol w="1905000">
                  <a:extLst>
                    <a:ext uri="{9D8B030D-6E8A-4147-A177-3AD203B41FA5}">
                      <a16:colId xmlns:a16="http://schemas.microsoft.com/office/drawing/2014/main" val="4020511193"/>
                    </a:ext>
                  </a:extLst>
                </a:gridCol>
                <a:gridCol w="719666">
                  <a:extLst>
                    <a:ext uri="{9D8B030D-6E8A-4147-A177-3AD203B41FA5}">
                      <a16:colId xmlns:a16="http://schemas.microsoft.com/office/drawing/2014/main" val="891275680"/>
                    </a:ext>
                  </a:extLst>
                </a:gridCol>
                <a:gridCol w="901704">
                  <a:extLst>
                    <a:ext uri="{9D8B030D-6E8A-4147-A177-3AD203B41FA5}">
                      <a16:colId xmlns:a16="http://schemas.microsoft.com/office/drawing/2014/main" val="1694437507"/>
                    </a:ext>
                  </a:extLst>
                </a:gridCol>
              </a:tblGrid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study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compariso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group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583776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HANCE, 20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lopidogrel + ASA vs Clopidogre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4,07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90415966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,09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52298026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HALES, 202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Ticagrelor + ASA vs ASA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7,87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084466086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3,14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41518231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RISTOTLE, 20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Apixaban vs warfari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overall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8,2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798989617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RISTOTLE, 20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 subgroup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4,54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740966776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-LY, 20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abigatran 150 mg vs warfar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overall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8,1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766175953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-LY, 20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 subgroup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4,22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61356759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-LY, 20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abigatran 110 mg vs warfari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overall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8,1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27690278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-LY, 20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 subgroup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4,22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15570152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ROCKET-AF, 20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ivaroxaban vs warfari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overall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4,26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03805359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ROCKET-AF, 201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M subgrou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5,69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2262493"/>
                  </a:ext>
                </a:extLst>
              </a:tr>
            </a:tbl>
          </a:graphicData>
        </a:graphic>
      </p:graphicFrame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65481EA1-0813-450F-A062-5CD0FEE998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9184436"/>
              </p:ext>
            </p:extLst>
          </p:nvPr>
        </p:nvGraphicFramePr>
        <p:xfrm>
          <a:off x="234615" y="290062"/>
          <a:ext cx="4811519" cy="220823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577252">
                  <a:extLst>
                    <a:ext uri="{9D8B030D-6E8A-4147-A177-3AD203B41FA5}">
                      <a16:colId xmlns:a16="http://schemas.microsoft.com/office/drawing/2014/main" val="3077048141"/>
                    </a:ext>
                  </a:extLst>
                </a:gridCol>
                <a:gridCol w="1583266">
                  <a:extLst>
                    <a:ext uri="{9D8B030D-6E8A-4147-A177-3AD203B41FA5}">
                      <a16:colId xmlns:a16="http://schemas.microsoft.com/office/drawing/2014/main" val="1185959036"/>
                    </a:ext>
                  </a:extLst>
                </a:gridCol>
                <a:gridCol w="708177">
                  <a:extLst>
                    <a:ext uri="{9D8B030D-6E8A-4147-A177-3AD203B41FA5}">
                      <a16:colId xmlns:a16="http://schemas.microsoft.com/office/drawing/2014/main" val="277019879"/>
                    </a:ext>
                  </a:extLst>
                </a:gridCol>
                <a:gridCol w="942824">
                  <a:extLst>
                    <a:ext uri="{9D8B030D-6E8A-4147-A177-3AD203B41FA5}">
                      <a16:colId xmlns:a16="http://schemas.microsoft.com/office/drawing/2014/main" val="2637171082"/>
                    </a:ext>
                  </a:extLst>
                </a:gridCol>
              </a:tblGrid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study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compariso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group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713412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DAPT, 20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P2Y12i + ASA vs ASA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-D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6,92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67235567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3,03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938269911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EGASUS-TIMI 54. 20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Ticagrelor + ASA vs ASA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4,3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1194504810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6,80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3571215040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COMPASS , 201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ivaroxaban + ASA vs AS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6,9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3496275691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1,35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829985361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OMPASS PAD</a:t>
                      </a:r>
                      <a:r>
                        <a:rPr lang="en-GB" sz="1000" u="none" strike="noStrike" dirty="0">
                          <a:effectLst/>
                        </a:rPr>
                        <a:t>, 201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Rivaroxaban + ASA vs AS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-D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,79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4291981464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,20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4183457386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VOYAGER-PAD 202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Rivaroxaban + ASA vs AS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-D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3,93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/>
                </a:tc>
                <a:extLst>
                  <a:ext uri="{0D108BD9-81ED-4DB2-BD59-A6C34878D82A}">
                    <a16:rowId xmlns:a16="http://schemas.microsoft.com/office/drawing/2014/main" val="601510836"/>
                  </a:ext>
                </a:extLst>
              </a:tr>
              <a:tr h="200749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2,62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159" marR="5159" marT="515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619969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8C187499-89F0-44AB-9CF2-18387BACB171}"/>
              </a:ext>
            </a:extLst>
          </p:cNvPr>
          <p:cNvSpPr txBox="1"/>
          <p:nvPr/>
        </p:nvSpPr>
        <p:spPr>
          <a:xfrm>
            <a:off x="234615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8B1488B-858C-460D-80A6-3EA92D0EB639}"/>
              </a:ext>
            </a:extLst>
          </p:cNvPr>
          <p:cNvSpPr txBox="1"/>
          <p:nvPr/>
        </p:nvSpPr>
        <p:spPr>
          <a:xfrm>
            <a:off x="234558" y="281499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B647BA04-7D36-442E-91B2-048B261A80AC}"/>
              </a:ext>
            </a:extLst>
          </p:cNvPr>
          <p:cNvGrpSpPr/>
          <p:nvPr/>
        </p:nvGrpSpPr>
        <p:grpSpPr>
          <a:xfrm>
            <a:off x="5019701" y="55278"/>
            <a:ext cx="4848074" cy="6421159"/>
            <a:chOff x="5492053" y="55278"/>
            <a:chExt cx="4375729" cy="6421159"/>
          </a:xfrm>
        </p:grpSpPr>
        <p:graphicFrame>
          <p:nvGraphicFramePr>
            <p:cNvPr id="14" name="Chart 13">
              <a:extLst>
                <a:ext uri="{FF2B5EF4-FFF2-40B4-BE49-F238E27FC236}">
                  <a16:creationId xmlns:a16="http://schemas.microsoft.com/office/drawing/2014/main" id="{DC0C9507-F3B0-4F9C-8B29-E41F850791F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8555801"/>
                </p:ext>
              </p:extLst>
            </p:nvPr>
          </p:nvGraphicFramePr>
          <p:xfrm>
            <a:off x="7647028" y="206460"/>
            <a:ext cx="2160000" cy="25726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0" name="Chart 19">
              <a:extLst>
                <a:ext uri="{FF2B5EF4-FFF2-40B4-BE49-F238E27FC236}">
                  <a16:creationId xmlns:a16="http://schemas.microsoft.com/office/drawing/2014/main" id="{1130B063-EC6D-4016-8F88-88DD2C6F1F6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65879130"/>
                </p:ext>
              </p:extLst>
            </p:nvPr>
          </p:nvGraphicFramePr>
          <p:xfrm>
            <a:off x="7527782" y="2977771"/>
            <a:ext cx="2340000" cy="33385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7B8D19B-B649-4CBA-8E0B-596F2746BD9A}"/>
                </a:ext>
              </a:extLst>
            </p:cNvPr>
            <p:cNvSpPr txBox="1"/>
            <p:nvPr/>
          </p:nvSpPr>
          <p:spPr>
            <a:xfrm>
              <a:off x="7972868" y="6168660"/>
              <a:ext cx="15624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% change (95%CI)</a:t>
              </a:r>
              <a:endParaRPr lang="en-GB" sz="1400" dirty="0"/>
            </a:p>
          </p:txBody>
        </p:sp>
        <p:graphicFrame>
          <p:nvGraphicFramePr>
            <p:cNvPr id="18" name="Chart 17">
              <a:extLst>
                <a:ext uri="{FF2B5EF4-FFF2-40B4-BE49-F238E27FC236}">
                  <a16:creationId xmlns:a16="http://schemas.microsoft.com/office/drawing/2014/main" id="{4BB70E1B-6350-4A21-9421-0BE4E23ED1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0602280"/>
                </p:ext>
              </p:extLst>
            </p:nvPr>
          </p:nvGraphicFramePr>
          <p:xfrm>
            <a:off x="5525921" y="55278"/>
            <a:ext cx="2160000" cy="28098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1" name="Chart 20">
              <a:extLst>
                <a:ext uri="{FF2B5EF4-FFF2-40B4-BE49-F238E27FC236}">
                  <a16:creationId xmlns:a16="http://schemas.microsoft.com/office/drawing/2014/main" id="{DCEF4D18-44CC-4BB6-9B60-BD9892409F5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8495625"/>
                </p:ext>
              </p:extLst>
            </p:nvPr>
          </p:nvGraphicFramePr>
          <p:xfrm>
            <a:off x="5492053" y="2999665"/>
            <a:ext cx="2193868" cy="33166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B3AB6AF-9125-42D6-93DA-AC424E6B0017}"/>
              </a:ext>
            </a:extLst>
          </p:cNvPr>
          <p:cNvSpPr txBox="1"/>
          <p:nvPr/>
        </p:nvSpPr>
        <p:spPr>
          <a:xfrm>
            <a:off x="5451180" y="2755881"/>
            <a:ext cx="1660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% reduction (95%CI)</a:t>
            </a:r>
            <a:endParaRPr lang="en-GB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24BF373-F22E-4BEB-9698-4E29CDB3020E}"/>
              </a:ext>
            </a:extLst>
          </p:cNvPr>
          <p:cNvSpPr txBox="1"/>
          <p:nvPr/>
        </p:nvSpPr>
        <p:spPr>
          <a:xfrm>
            <a:off x="7825914" y="2738099"/>
            <a:ext cx="1478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% change (95%CI)</a:t>
            </a:r>
            <a:endParaRPr lang="en-GB" sz="1400" dirty="0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61ACDDE-32D1-461E-8DF1-F564D34E06DC}"/>
              </a:ext>
            </a:extLst>
          </p:cNvPr>
          <p:cNvCxnSpPr>
            <a:cxnSpLocks/>
          </p:cNvCxnSpPr>
          <p:nvPr/>
        </p:nvCxnSpPr>
        <p:spPr>
          <a:xfrm>
            <a:off x="8626014" y="468566"/>
            <a:ext cx="0" cy="202973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34740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259</Words>
  <Application>Microsoft Office PowerPoint</Application>
  <PresentationFormat>A4 Paper (210x297 mm)</PresentationFormat>
  <Paragraphs>9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ppadol Kietsiriroje</dc:creator>
  <cp:lastModifiedBy>Noppadol Kietsiriroje</cp:lastModifiedBy>
  <cp:revision>5</cp:revision>
  <dcterms:created xsi:type="dcterms:W3CDTF">2021-01-15T14:19:48Z</dcterms:created>
  <dcterms:modified xsi:type="dcterms:W3CDTF">2021-01-26T15:28:46Z</dcterms:modified>
</cp:coreProperties>
</file>